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6" r:id="rId2"/>
    <p:sldId id="278" r:id="rId3"/>
    <p:sldId id="267" r:id="rId4"/>
    <p:sldId id="271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12" d="100"/>
          <a:sy n="112" d="100"/>
        </p:scale>
        <p:origin x="784" y="-5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87641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0228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31947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4903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3573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9359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2303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6997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1171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5864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17181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10602D-2367-4308-9A03-42C6915BB318}" type="datetimeFigureOut">
              <a:rPr lang="en-AU" smtClean="0"/>
              <a:t>7/04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13F9C-E243-45EB-9BDD-4CC20CE209C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25049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>
            <a:extLst>
              <a:ext uri="{FF2B5EF4-FFF2-40B4-BE49-F238E27FC236}">
                <a16:creationId xmlns:a16="http://schemas.microsoft.com/office/drawing/2014/main" id="{575A4A97-BE2C-4815-B67D-60E11984814E}"/>
              </a:ext>
            </a:extLst>
          </p:cNvPr>
          <p:cNvSpPr txBox="1"/>
          <p:nvPr/>
        </p:nvSpPr>
        <p:spPr>
          <a:xfrm>
            <a:off x="394186" y="9534714"/>
            <a:ext cx="6069628" cy="8891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The distributions of grain number (GN) per spike, grain weight (GW) per spike, and plant height in the DH population of Westonia and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Kauz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in glasshouse (GH), Katanning (Ka) and Shenton Park (SH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7E4A84C-1DA1-4F07-9068-958A92E368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3428" y="1768132"/>
            <a:ext cx="3024000" cy="75011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01058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DC09F6A-2AE0-44B1-AD25-A8E1F690F8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005" y="1871975"/>
            <a:ext cx="5821680" cy="663702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C71B1BA4-8868-48E1-A800-D47C6B04FC0E}"/>
              </a:ext>
            </a:extLst>
          </p:cNvPr>
          <p:cNvSpPr txBox="1"/>
          <p:nvPr/>
        </p:nvSpPr>
        <p:spPr>
          <a:xfrm>
            <a:off x="347031" y="8829496"/>
            <a:ext cx="6069628" cy="889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2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The gene expression levels of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TraesCS4B02G240100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TraesCS4B02G251800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TraesCS4B02G262900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which showed one more transcript in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Kauz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The vertical bars represent SE; values with the same letter are not significantly different at </a:t>
            </a:r>
            <a:r>
              <a:rPr lang="en-US" sz="1200" i="1" dirty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ea typeface="SimSun" pitchFamily="2" charset="-122"/>
                <a:cs typeface="Arial" panose="020B0604020202020204" pitchFamily="34" charset="0"/>
              </a:rPr>
              <a:t> &lt; 0.05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71866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EE9A4A7-DFD5-49CF-AD8A-1137D12F68B0}"/>
              </a:ext>
            </a:extLst>
          </p:cNvPr>
          <p:cNvSpPr txBox="1"/>
          <p:nvPr/>
        </p:nvSpPr>
        <p:spPr>
          <a:xfrm>
            <a:off x="387920" y="6498533"/>
            <a:ext cx="5745866" cy="6129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3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Primers used for </a:t>
            </a:r>
            <a:r>
              <a:rPr lang="en-AU" sz="1200" i="1" dirty="0">
                <a:latin typeface="Arial" panose="020B0604020202020204" pitchFamily="34" charset="0"/>
                <a:cs typeface="Arial" panose="020B0604020202020204" pitchFamily="34" charset="0"/>
              </a:rPr>
              <a:t>Ta</a:t>
            </a:r>
            <a:r>
              <a:rPr lang="en-AU" sz="1200" i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GSr-4B</a:t>
            </a:r>
            <a:r>
              <a:rPr lang="en-AU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gene isolation in Westonia and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Kauz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AU" sz="12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and its locations on the genome sequence</a:t>
            </a:r>
            <a:endParaRPr lang="en-A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4F67A5C-878D-4B31-8B31-2272C4BF57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593" y="4657147"/>
            <a:ext cx="5684520" cy="1036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64867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82799ABA-A7E1-4580-B84A-3BD23C856897}"/>
              </a:ext>
            </a:extLst>
          </p:cNvPr>
          <p:cNvSpPr txBox="1"/>
          <p:nvPr/>
        </p:nvSpPr>
        <p:spPr>
          <a:xfrm>
            <a:off x="425038" y="9677400"/>
            <a:ext cx="5884264" cy="8935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4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Different gene expression levels of </a:t>
            </a:r>
            <a:r>
              <a:rPr lang="en-AU" sz="1200" i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raesCS4B02G222300 </a:t>
            </a:r>
            <a:r>
              <a:rPr lang="en-AU" sz="1200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nd </a:t>
            </a:r>
            <a:r>
              <a:rPr lang="en-AU" sz="1200" i="1" dirty="0"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TraesCS4B02G225400 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between Westonia and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Kauz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 in different growth stages (days after anthesis) and treatments. K: </a:t>
            </a:r>
            <a:r>
              <a:rPr lang="en-AU" sz="1200" dirty="0" err="1">
                <a:latin typeface="Arial" panose="020B0604020202020204" pitchFamily="34" charset="0"/>
                <a:cs typeface="Arial" panose="020B0604020202020204" pitchFamily="34" charset="0"/>
              </a:rPr>
              <a:t>Kauz</a:t>
            </a:r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; Wes: Westonia; D: Drought; W: irrigated </a:t>
            </a:r>
            <a:endParaRPr lang="en-AU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7A9F9AC-1BB2-4136-8A66-B4935F50F5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6750" y="2754549"/>
            <a:ext cx="4320000" cy="62336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2618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46</TotalTime>
  <Words>151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uan Zhang</dc:creator>
  <cp:lastModifiedBy>Jingjuan Zhang</cp:lastModifiedBy>
  <cp:revision>83</cp:revision>
  <dcterms:created xsi:type="dcterms:W3CDTF">2021-09-23T08:26:59Z</dcterms:created>
  <dcterms:modified xsi:type="dcterms:W3CDTF">2022-04-07T09:00:49Z</dcterms:modified>
</cp:coreProperties>
</file>